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96" autoAdjust="0"/>
    <p:restoredTop sz="94660"/>
  </p:normalViewPr>
  <p:slideViewPr>
    <p:cSldViewPr snapToGrid="0">
      <p:cViewPr varScale="1">
        <p:scale>
          <a:sx n="86" d="100"/>
          <a:sy n="86" d="100"/>
        </p:scale>
        <p:origin x="37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1F7E1-0091-4ACF-AE1F-30F16E82B026}" type="datetimeFigureOut">
              <a:rPr lang="de-DE" smtClean="0"/>
              <a:t>29.03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08F67-214C-4568-8D3D-0935544F31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255047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1F7E1-0091-4ACF-AE1F-30F16E82B026}" type="datetimeFigureOut">
              <a:rPr lang="de-DE" smtClean="0"/>
              <a:t>29.03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08F67-214C-4568-8D3D-0935544F31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31210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1F7E1-0091-4ACF-AE1F-30F16E82B026}" type="datetimeFigureOut">
              <a:rPr lang="de-DE" smtClean="0"/>
              <a:t>29.03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08F67-214C-4568-8D3D-0935544F31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58545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1F7E1-0091-4ACF-AE1F-30F16E82B026}" type="datetimeFigureOut">
              <a:rPr lang="de-DE" smtClean="0"/>
              <a:t>29.03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08F67-214C-4568-8D3D-0935544F31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675367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1F7E1-0091-4ACF-AE1F-30F16E82B026}" type="datetimeFigureOut">
              <a:rPr lang="de-DE" smtClean="0"/>
              <a:t>29.03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08F67-214C-4568-8D3D-0935544F31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85908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1F7E1-0091-4ACF-AE1F-30F16E82B026}" type="datetimeFigureOut">
              <a:rPr lang="de-DE" smtClean="0"/>
              <a:t>29.03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08F67-214C-4568-8D3D-0935544F31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1403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1F7E1-0091-4ACF-AE1F-30F16E82B026}" type="datetimeFigureOut">
              <a:rPr lang="de-DE" smtClean="0"/>
              <a:t>29.03.202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08F67-214C-4568-8D3D-0935544F31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07328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1F7E1-0091-4ACF-AE1F-30F16E82B026}" type="datetimeFigureOut">
              <a:rPr lang="de-DE" smtClean="0"/>
              <a:t>29.03.202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08F67-214C-4568-8D3D-0935544F31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918036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1F7E1-0091-4ACF-AE1F-30F16E82B026}" type="datetimeFigureOut">
              <a:rPr lang="de-DE" smtClean="0"/>
              <a:t>29.03.202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08F67-214C-4568-8D3D-0935544F31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00332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1F7E1-0091-4ACF-AE1F-30F16E82B026}" type="datetimeFigureOut">
              <a:rPr lang="de-DE" smtClean="0"/>
              <a:t>29.03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08F67-214C-4568-8D3D-0935544F31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80249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1F7E1-0091-4ACF-AE1F-30F16E82B026}" type="datetimeFigureOut">
              <a:rPr lang="de-DE" smtClean="0"/>
              <a:t>29.03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08F67-214C-4568-8D3D-0935544F31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75282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C1F7E1-0091-4ACF-AE1F-30F16E82B026}" type="datetimeFigureOut">
              <a:rPr lang="de-DE" smtClean="0"/>
              <a:t>29.03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E08F67-214C-4568-8D3D-0935544F31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40853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754141" y="386499"/>
            <a:ext cx="93360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Figure S1. </a:t>
            </a:r>
            <a:r>
              <a:rPr lang="en-GB" dirty="0"/>
              <a:t>Anthocyanin stability at 4°C in ElderCraft 3.2% measured by the pH Differential Method</a:t>
            </a:r>
            <a:endParaRPr lang="de-DE" dirty="0"/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69589" y="1195883"/>
            <a:ext cx="6216988" cy="39600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5195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 Presentation</vt:lpstr>
    </vt:vector>
  </TitlesOfParts>
  <Company>Universitätsklinikum Erlang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etz, Christian</dc:creator>
  <cp:lastModifiedBy>MDPI</cp:lastModifiedBy>
  <cp:revision>6</cp:revision>
  <dcterms:created xsi:type="dcterms:W3CDTF">2025-01-13T09:52:32Z</dcterms:created>
  <dcterms:modified xsi:type="dcterms:W3CDTF">2025-03-29T08:06:05Z</dcterms:modified>
</cp:coreProperties>
</file>